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3394" autoAdjust="0"/>
  </p:normalViewPr>
  <p:slideViewPr>
    <p:cSldViewPr snapToGrid="0">
      <p:cViewPr varScale="1">
        <p:scale>
          <a:sx n="74" d="100"/>
          <a:sy n="74" d="100"/>
        </p:scale>
        <p:origin x="104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660865-09FC-4C8B-AFA3-7F74021A6F9F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D86C6C-2652-4014-843A-A87C382EC9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360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Additional File </a:t>
            </a:r>
            <a:r>
              <a:rPr lang="en-US" b="1" dirty="0" smtClean="0"/>
              <a:t>3: </a:t>
            </a:r>
            <a:r>
              <a:rPr lang="en-US" b="1" dirty="0" smtClean="0"/>
              <a:t>Table S1. DAVID results from expanded gene list (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DR </a:t>
            </a:r>
            <a:r>
              <a:rPr lang="en-US" b="1" dirty="0" smtClean="0"/>
              <a:t>≤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0.1)</a:t>
            </a:r>
            <a:r>
              <a:rPr lang="en-US" b="1" baseline="0" dirty="0" smtClean="0"/>
              <a:t>. </a:t>
            </a:r>
            <a:r>
              <a:rPr lang="en-US" baseline="0" dirty="0" smtClean="0"/>
              <a:t>Lists of genes differentially expressed between young and old mice at FDR </a:t>
            </a:r>
            <a:r>
              <a:rPr lang="en-US" sz="1200" b="0" dirty="0" smtClean="0">
                <a:solidFill>
                  <a:srgbClr val="000000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≤0.1 in naïve and memory</a:t>
            </a:r>
            <a:r>
              <a:rPr lang="en-US" sz="1200" b="0" baseline="0" dirty="0" smtClean="0">
                <a:solidFill>
                  <a:srgbClr val="000000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CD4+ T cells were used as input, with all expressed genes in naïve and memory cells used as background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oad terms such as “signal” and “disulfide bond” were excluded. A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DR of 0.05 was used as a threshold for enriched terms. No terms were significantly enriched in down-regulated gene list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AD4B55-A05D-4820-9737-5DBBF42226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0198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143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235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785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99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65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684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690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088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816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497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913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1D2CA-7176-4FE4-A425-9CA92A5975F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89270B-37EA-4BA3-A057-A9F3190C6D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190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2743201" y="685801"/>
          <a:ext cx="6857999" cy="3865045"/>
        </p:xfrm>
        <a:graphic>
          <a:graphicData uri="http://schemas.openxmlformats.org/drawingml/2006/table">
            <a:tbl>
              <a:tblPr firstRow="1" firstCol="1">
                <a:tableStyleId>{9D7B26C5-4107-4FEC-AEDC-1716B250A1EF}</a:tableStyleId>
              </a:tblPr>
              <a:tblGrid>
                <a:gridCol w="847618"/>
                <a:gridCol w="1232899"/>
                <a:gridCol w="3005191"/>
                <a:gridCol w="539393"/>
                <a:gridCol w="616449"/>
                <a:gridCol w="616449"/>
              </a:tblGrid>
              <a:tr h="18032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Gene lis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5" marR="7415" marT="74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+mn-lt"/>
                        </a:rPr>
                        <a:t>Categor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5" marR="7415" marT="74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+mn-lt"/>
                        </a:rPr>
                        <a:t>Term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5" marR="7415" marT="74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+mn-lt"/>
                        </a:rPr>
                        <a:t>Count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5" marR="7415" marT="74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  <a:latin typeface="+mn-lt"/>
                        </a:rPr>
                        <a:t>PValu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5" marR="7415" marT="741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  <a:latin typeface="+mn-lt"/>
                        </a:rPr>
                        <a:t>FD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5" marR="7415" marT="7415" marB="0" anchor="b"/>
                </a:tc>
              </a:tr>
              <a:tr h="276879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aïve Up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TERM_CC_F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:0009897~external side of plasma membran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7.10E-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81E-07</a:t>
                      </a:r>
                    </a:p>
                  </a:txBody>
                  <a:tcPr marL="9525" marR="9525" marT="9525" marB="0" anchor="b"/>
                </a:tc>
              </a:tr>
              <a:tr h="304800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TERM_BP_F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:0006955~immune respons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16E-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91E-05</a:t>
                      </a:r>
                    </a:p>
                  </a:txBody>
                  <a:tcPr marL="9525" marR="9525" marT="9525" marB="0" anchor="b"/>
                </a:tc>
              </a:tr>
              <a:tr h="276765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EGG_PATHWA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mu04060:Cytokine-cytokine receptor interaction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04E-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453</a:t>
                      </a:r>
                    </a:p>
                  </a:txBody>
                  <a:tcPr marL="9525" marR="9525" marT="9525" marB="0" anchor="b"/>
                </a:tc>
              </a:tr>
              <a:tr h="268974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NTERPRO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PR017452:GPCR, rhodopsin-like superfamily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12E-05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888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TERM_BP_F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:0042981~regulation of apoptosi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76E-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9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5402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aïve Down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TERM_MF_FAT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:0003705~RNA polymerase II transcription factor activity, enhancer binding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.46E-04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6003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25044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TERM_MF_FAT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:0016563~transcription activator activity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2449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32536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25044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emory Up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EGG_PATHWAY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mu04060:Cytokine-cytokine receptor interaction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8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48E-07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.33E-06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25044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TERM_MF_FAT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:0004866~endopeptidase inhibitor activity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.70E-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008</a:t>
                      </a:r>
                    </a:p>
                  </a:txBody>
                  <a:tcPr marL="9525" marR="9525" marT="9525" marB="0" anchor="b"/>
                </a:tc>
              </a:tr>
              <a:tr h="325044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P_PIR_KEYWORDS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ytokine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.51E-06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114</a:t>
                      </a:r>
                    </a:p>
                  </a:txBody>
                  <a:tcPr marL="9525" marR="9525" marT="952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9152">
                <a:tc>
                  <a:txBody>
                    <a:bodyPr/>
                    <a:lstStyle/>
                    <a:p>
                      <a:pPr algn="l" fontAlgn="b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TERM_BP_F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O:0045597~positive regulation of cell differentiati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80E-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004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9152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emory Dow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895601" y="152400"/>
            <a:ext cx="10182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b"/>
            <a:r>
              <a:rPr lang="en-US" dirty="0"/>
              <a:t>FDR ≤0.1</a:t>
            </a:r>
            <a:endParaRPr lang="en-US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77573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5</Words>
  <Application>Microsoft Office PowerPoint</Application>
  <PresentationFormat>Widescreen</PresentationFormat>
  <Paragraphs>7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 T</dc:creator>
  <cp:lastModifiedBy>J T</cp:lastModifiedBy>
  <cp:revision>2</cp:revision>
  <dcterms:created xsi:type="dcterms:W3CDTF">2016-12-29T21:11:27Z</dcterms:created>
  <dcterms:modified xsi:type="dcterms:W3CDTF">2017-04-03T01:41:42Z</dcterms:modified>
</cp:coreProperties>
</file>